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13" r:id="rId1"/>
  </p:sldMasterIdLst>
  <p:sldIdLst>
    <p:sldId id="260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87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F7E0-D329-4FB4-AC62-85A5C1353F5B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AD9E1-17FC-454F-9703-0250D25B7C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77857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F7E0-D329-4FB4-AC62-85A5C1353F5B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AD9E1-17FC-454F-9703-0250D25B7C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5892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F7E0-D329-4FB4-AC62-85A5C1353F5B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AD9E1-17FC-454F-9703-0250D25B7C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22989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F7E0-D329-4FB4-AC62-85A5C1353F5B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AD9E1-17FC-454F-9703-0250D25B7C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367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F7E0-D329-4FB4-AC62-85A5C1353F5B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AD9E1-17FC-454F-9703-0250D25B7C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2685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F7E0-D329-4FB4-AC62-85A5C1353F5B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AD9E1-17FC-454F-9703-0250D25B7C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5555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F7E0-D329-4FB4-AC62-85A5C1353F5B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AD9E1-17FC-454F-9703-0250D25B7C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65934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F7E0-D329-4FB4-AC62-85A5C1353F5B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AD9E1-17FC-454F-9703-0250D25B7C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4299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F7E0-D329-4FB4-AC62-85A5C1353F5B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AD9E1-17FC-454F-9703-0250D25B7C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57480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F7E0-D329-4FB4-AC62-85A5C1353F5B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AD9E1-17FC-454F-9703-0250D25B7C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0876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F7E0-D329-4FB4-AC62-85A5C1353F5B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6AD9E1-17FC-454F-9703-0250D25B7C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21284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42F7E0-D329-4FB4-AC62-85A5C1353F5B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6AD9E1-17FC-454F-9703-0250D25B7C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0813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14" r:id="rId1"/>
    <p:sldLayoutId id="2147483715" r:id="rId2"/>
    <p:sldLayoutId id="2147483716" r:id="rId3"/>
    <p:sldLayoutId id="2147483717" r:id="rId4"/>
    <p:sldLayoutId id="2147483718" r:id="rId5"/>
    <p:sldLayoutId id="2147483719" r:id="rId6"/>
    <p:sldLayoutId id="2147483720" r:id="rId7"/>
    <p:sldLayoutId id="2147483721" r:id="rId8"/>
    <p:sldLayoutId id="2147483722" r:id="rId9"/>
    <p:sldLayoutId id="2147483723" r:id="rId10"/>
    <p:sldLayoutId id="2147483724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図 19"/>
          <p:cNvPicPr>
            <a:picLocks noChangeAspect="1"/>
          </p:cNvPicPr>
          <p:nvPr/>
        </p:nvPicPr>
        <p:blipFill rotWithShape="1">
          <a:blip r:embed="rId2"/>
          <a:srcRect l="2593" t="1963" r="1411" b="4017"/>
          <a:stretch/>
        </p:blipFill>
        <p:spPr>
          <a:xfrm>
            <a:off x="1845601" y="1760413"/>
            <a:ext cx="4143245" cy="2972067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 rotWithShape="1">
          <a:blip r:embed="rId3"/>
          <a:srcRect l="2594" t="1965" r="1410" b="3890"/>
          <a:stretch/>
        </p:blipFill>
        <p:spPr>
          <a:xfrm>
            <a:off x="6254847" y="1760414"/>
            <a:ext cx="4137662" cy="2972067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BB7E3BF-5B2A-1EAC-6B25-AFD77559E5AB}"/>
              </a:ext>
            </a:extLst>
          </p:cNvPr>
          <p:cNvSpPr txBox="1"/>
          <p:nvPr/>
        </p:nvSpPr>
        <p:spPr>
          <a:xfrm>
            <a:off x="4816791" y="6151732"/>
            <a:ext cx="2578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upplementary Figure 2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2753B16-FE49-16B9-BC62-B0E134F72B7C}"/>
              </a:ext>
            </a:extLst>
          </p:cNvPr>
          <p:cNvSpPr txBox="1"/>
          <p:nvPr/>
        </p:nvSpPr>
        <p:spPr>
          <a:xfrm>
            <a:off x="2867993" y="1328203"/>
            <a:ext cx="21916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A     CKD stages 1</a:t>
            </a:r>
            <a:r>
              <a:rPr kumimoji="1" lang="en-US" altLang="ja-JP" sz="1800" b="1" i="0" u="none" strike="noStrike" kern="105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–3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CCFA9FB-9ED5-EAE1-CB28-27D7698E78A1}"/>
              </a:ext>
            </a:extLst>
          </p:cNvPr>
          <p:cNvSpPr txBox="1"/>
          <p:nvPr/>
        </p:nvSpPr>
        <p:spPr>
          <a:xfrm>
            <a:off x="7282068" y="1328366"/>
            <a:ext cx="2191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B     CKD stages 4</a:t>
            </a:r>
            <a:r>
              <a:rPr kumimoji="1" lang="en-US" altLang="ja-JP" sz="1800" b="1" i="0" u="none" strike="noStrike" kern="105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–5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8D3F805-5DC7-7C87-1B10-7B994E410F3A}"/>
              </a:ext>
            </a:extLst>
          </p:cNvPr>
          <p:cNvSpPr txBox="1"/>
          <p:nvPr/>
        </p:nvSpPr>
        <p:spPr>
          <a:xfrm>
            <a:off x="3390247" y="549337"/>
            <a:ext cx="5729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ROC analysis of BNP as a predictor of composite events 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8E38267-7995-3A2F-18E3-F331F03F6B2E}"/>
              </a:ext>
            </a:extLst>
          </p:cNvPr>
          <p:cNvSpPr txBox="1"/>
          <p:nvPr/>
        </p:nvSpPr>
        <p:spPr>
          <a:xfrm rot="16200000">
            <a:off x="1115211" y="2880143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ensitivity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2B7585B-7372-5F52-342E-19C7CBBCB96E}"/>
              </a:ext>
            </a:extLst>
          </p:cNvPr>
          <p:cNvSpPr txBox="1"/>
          <p:nvPr/>
        </p:nvSpPr>
        <p:spPr>
          <a:xfrm flipH="1">
            <a:off x="3257811" y="4612660"/>
            <a:ext cx="17445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-Specificity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53F8501-4CFF-B6E4-434A-D4F172BE17B2}"/>
              </a:ext>
            </a:extLst>
          </p:cNvPr>
          <p:cNvSpPr txBox="1"/>
          <p:nvPr/>
        </p:nvSpPr>
        <p:spPr>
          <a:xfrm>
            <a:off x="3644034" y="3485437"/>
            <a:ext cx="234551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AUC =  0.733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95%CI: 0.681, 0.784)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005C100-C49B-E4EA-222E-E8A92A3186B7}"/>
              </a:ext>
            </a:extLst>
          </p:cNvPr>
          <p:cNvSpPr txBox="1"/>
          <p:nvPr/>
        </p:nvSpPr>
        <p:spPr>
          <a:xfrm>
            <a:off x="8072725" y="3485437"/>
            <a:ext cx="234551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AUC =  0.64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95%CI: 0.588, 0.692)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C1A6725-6FEC-FF9D-C2D0-4E273C7FCA58}"/>
              </a:ext>
            </a:extLst>
          </p:cNvPr>
          <p:cNvSpPr txBox="1"/>
          <p:nvPr/>
        </p:nvSpPr>
        <p:spPr>
          <a:xfrm rot="16200000">
            <a:off x="5464886" y="2880306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ensitivity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BE481EA-6952-AAC6-4208-D401C7188BAD}"/>
              </a:ext>
            </a:extLst>
          </p:cNvPr>
          <p:cNvSpPr txBox="1"/>
          <p:nvPr/>
        </p:nvSpPr>
        <p:spPr>
          <a:xfrm flipH="1">
            <a:off x="7681091" y="4612823"/>
            <a:ext cx="17445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-Specificity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D6590D7-63F4-1236-832F-E0797A8A69AD}"/>
              </a:ext>
            </a:extLst>
          </p:cNvPr>
          <p:cNvSpPr txBox="1"/>
          <p:nvPr/>
        </p:nvSpPr>
        <p:spPr>
          <a:xfrm>
            <a:off x="1773757" y="5211274"/>
            <a:ext cx="74431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ROC, receiver operating characteristic; BNP, B-type natriuretic peptid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KD, chronic kidney disease; AUC, area under curve; CI, confidence interval.</a:t>
            </a:r>
          </a:p>
        </p:txBody>
      </p:sp>
    </p:spTree>
    <p:extLst>
      <p:ext uri="{BB962C8B-B14F-4D97-AF65-F5344CB8AC3E}">
        <p14:creationId xmlns:p14="http://schemas.microsoft.com/office/powerpoint/2010/main" val="33039445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Words>77</Words>
  <Application>Microsoft Office PowerPoint</Application>
  <PresentationFormat>ワイド画面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kayama</dc:creator>
  <cp:lastModifiedBy>腎臓内科 九州医療</cp:lastModifiedBy>
  <cp:revision>6</cp:revision>
  <dcterms:created xsi:type="dcterms:W3CDTF">2024-05-13T12:31:56Z</dcterms:created>
  <dcterms:modified xsi:type="dcterms:W3CDTF">2024-05-15T01:47:58Z</dcterms:modified>
</cp:coreProperties>
</file>